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83" r:id="rId5"/>
    <p:sldId id="257" r:id="rId6"/>
    <p:sldId id="263" r:id="rId7"/>
    <p:sldId id="280" r:id="rId8"/>
    <p:sldId id="281" r:id="rId9"/>
    <p:sldId id="282" r:id="rId10"/>
  </p:sldIdLst>
  <p:sldSz cx="9144000" cy="6858000" type="screen4x3"/>
  <p:notesSz cx="6858000" cy="14382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2B3288-9944-40F2-9DC9-8304C1331017}" v="5" dt="2020-01-27T18:01:58.42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7556" autoAdjust="0"/>
  </p:normalViewPr>
  <p:slideViewPr>
    <p:cSldViewPr snapToGrid="0" snapToObjects="1">
      <p:cViewPr>
        <p:scale>
          <a:sx n="76" d="100"/>
          <a:sy n="76" d="100"/>
        </p:scale>
        <p:origin x="284" y="3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iangang Liu" userId="0f1f0531-001f-45a0-a6c2-2f60a9e7edbe" providerId="ADAL" clId="{3A84A6FC-84F1-420C-9F27-82F5EC4DEFAA}"/>
    <pc:docChg chg="delSld">
      <pc:chgData name="Jiangang Liu" userId="0f1f0531-001f-45a0-a6c2-2f60a9e7edbe" providerId="ADAL" clId="{3A84A6FC-84F1-420C-9F27-82F5EC4DEFAA}" dt="2020-01-22T18:15:15.510" v="0" actId="2696"/>
      <pc:docMkLst>
        <pc:docMk/>
      </pc:docMkLst>
    </pc:docChg>
  </pc:docChgLst>
  <pc:docChgLst>
    <pc:chgData name="Jiangang Liu" userId="S::liu_jiangang@lilly.com::0f1f0531-001f-45a0-a6c2-2f60a9e7edbe" providerId="AD" clId="Web-{C57E2A1E-07E3-4B53-80CC-0DEA07CDEE08}"/>
    <pc:docChg chg="modSld">
      <pc:chgData name="Jiangang Liu" userId="S::liu_jiangang@lilly.com::0f1f0531-001f-45a0-a6c2-2f60a9e7edbe" providerId="AD" clId="Web-{C57E2A1E-07E3-4B53-80CC-0DEA07CDEE08}" dt="2020-01-24T15:20:32.748" v="3" actId="20577"/>
      <pc:docMkLst>
        <pc:docMk/>
      </pc:docMkLst>
      <pc:sldChg chg="modSp">
        <pc:chgData name="Jiangang Liu" userId="S::liu_jiangang@lilly.com::0f1f0531-001f-45a0-a6c2-2f60a9e7edbe" providerId="AD" clId="Web-{C57E2A1E-07E3-4B53-80CC-0DEA07CDEE08}" dt="2020-01-24T15:20:32.748" v="2" actId="20577"/>
        <pc:sldMkLst>
          <pc:docMk/>
          <pc:sldMk cId="2381304335" sldId="257"/>
        </pc:sldMkLst>
        <pc:spChg chg="mod">
          <ac:chgData name="Jiangang Liu" userId="S::liu_jiangang@lilly.com::0f1f0531-001f-45a0-a6c2-2f60a9e7edbe" providerId="AD" clId="Web-{C57E2A1E-07E3-4B53-80CC-0DEA07CDEE08}" dt="2020-01-24T15:20:32.748" v="2" actId="20577"/>
          <ac:spMkLst>
            <pc:docMk/>
            <pc:sldMk cId="2381304335" sldId="257"/>
            <ac:spMk id="4" creationId="{00000000-0000-0000-0000-000000000000}"/>
          </ac:spMkLst>
        </pc:spChg>
      </pc:sldChg>
    </pc:docChg>
  </pc:docChgLst>
  <pc:docChgLst>
    <pc:chgData name="Jiangang Liu" userId="0f1f0531-001f-45a0-a6c2-2f60a9e7edbe" providerId="ADAL" clId="{6CBE34C4-9A17-482E-9A7F-477432CBC8B5}"/>
  </pc:docChgLst>
  <pc:docChgLst>
    <pc:chgData name="Jiangang Liu" userId="0f1f0531-001f-45a0-a6c2-2f60a9e7edbe" providerId="ADAL" clId="{2D2B3288-9944-40F2-9DC9-8304C1331017}"/>
    <pc:docChg chg="modSld">
      <pc:chgData name="Jiangang Liu" userId="0f1f0531-001f-45a0-a6c2-2f60a9e7edbe" providerId="ADAL" clId="{2D2B3288-9944-40F2-9DC9-8304C1331017}" dt="2020-01-27T18:01:58.422" v="31" actId="207"/>
      <pc:docMkLst>
        <pc:docMk/>
      </pc:docMkLst>
      <pc:sldChg chg="modSp">
        <pc:chgData name="Jiangang Liu" userId="0f1f0531-001f-45a0-a6c2-2f60a9e7edbe" providerId="ADAL" clId="{2D2B3288-9944-40F2-9DC9-8304C1331017}" dt="2020-01-27T18:00:12.817" v="18" actId="113"/>
        <pc:sldMkLst>
          <pc:docMk/>
          <pc:sldMk cId="2381304335" sldId="257"/>
        </pc:sldMkLst>
        <pc:spChg chg="mod">
          <ac:chgData name="Jiangang Liu" userId="0f1f0531-001f-45a0-a6c2-2f60a9e7edbe" providerId="ADAL" clId="{2D2B3288-9944-40F2-9DC9-8304C1331017}" dt="2020-01-27T18:00:12.817" v="18" actId="113"/>
          <ac:spMkLst>
            <pc:docMk/>
            <pc:sldMk cId="2381304335" sldId="257"/>
            <ac:spMk id="4" creationId="{00000000-0000-0000-0000-000000000000}"/>
          </ac:spMkLst>
        </pc:spChg>
        <pc:spChg chg="mod">
          <ac:chgData name="Jiangang Liu" userId="0f1f0531-001f-45a0-a6c2-2f60a9e7edbe" providerId="ADAL" clId="{2D2B3288-9944-40F2-9DC9-8304C1331017}" dt="2020-01-27T17:59:50.204" v="11" actId="207"/>
          <ac:spMkLst>
            <pc:docMk/>
            <pc:sldMk cId="2381304335" sldId="257"/>
            <ac:spMk id="5" creationId="{00000000-0000-0000-0000-000000000000}"/>
          </ac:spMkLst>
        </pc:spChg>
      </pc:sldChg>
      <pc:sldChg chg="modSp">
        <pc:chgData name="Jiangang Liu" userId="0f1f0531-001f-45a0-a6c2-2f60a9e7edbe" providerId="ADAL" clId="{2D2B3288-9944-40F2-9DC9-8304C1331017}" dt="2020-01-27T18:00:40.650" v="22" actId="1076"/>
        <pc:sldMkLst>
          <pc:docMk/>
          <pc:sldMk cId="3850866488" sldId="263"/>
        </pc:sldMkLst>
        <pc:spChg chg="mod">
          <ac:chgData name="Jiangang Liu" userId="0f1f0531-001f-45a0-a6c2-2f60a9e7edbe" providerId="ADAL" clId="{2D2B3288-9944-40F2-9DC9-8304C1331017}" dt="2020-01-27T18:00:40.650" v="22" actId="1076"/>
          <ac:spMkLst>
            <pc:docMk/>
            <pc:sldMk cId="3850866488" sldId="263"/>
            <ac:spMk id="34" creationId="{00000000-0000-0000-0000-000000000000}"/>
          </ac:spMkLst>
        </pc:spChg>
      </pc:sldChg>
      <pc:sldChg chg="modSp">
        <pc:chgData name="Jiangang Liu" userId="0f1f0531-001f-45a0-a6c2-2f60a9e7edbe" providerId="ADAL" clId="{2D2B3288-9944-40F2-9DC9-8304C1331017}" dt="2020-01-27T18:01:07.178" v="25" actId="207"/>
        <pc:sldMkLst>
          <pc:docMk/>
          <pc:sldMk cId="3448914108" sldId="280"/>
        </pc:sldMkLst>
        <pc:spChg chg="mod">
          <ac:chgData name="Jiangang Liu" userId="0f1f0531-001f-45a0-a6c2-2f60a9e7edbe" providerId="ADAL" clId="{2D2B3288-9944-40F2-9DC9-8304C1331017}" dt="2020-01-27T18:01:07.178" v="25" actId="207"/>
          <ac:spMkLst>
            <pc:docMk/>
            <pc:sldMk cId="3448914108" sldId="280"/>
            <ac:spMk id="9" creationId="{00000000-0000-0000-0000-000000000000}"/>
          </ac:spMkLst>
        </pc:spChg>
      </pc:sldChg>
      <pc:sldChg chg="modSp">
        <pc:chgData name="Jiangang Liu" userId="0f1f0531-001f-45a0-a6c2-2f60a9e7edbe" providerId="ADAL" clId="{2D2B3288-9944-40F2-9DC9-8304C1331017}" dt="2020-01-27T18:01:43.748" v="28" actId="207"/>
        <pc:sldMkLst>
          <pc:docMk/>
          <pc:sldMk cId="2495161334" sldId="281"/>
        </pc:sldMkLst>
        <pc:spChg chg="mod">
          <ac:chgData name="Jiangang Liu" userId="0f1f0531-001f-45a0-a6c2-2f60a9e7edbe" providerId="ADAL" clId="{2D2B3288-9944-40F2-9DC9-8304C1331017}" dt="2020-01-27T18:01:43.748" v="28" actId="207"/>
          <ac:spMkLst>
            <pc:docMk/>
            <pc:sldMk cId="2495161334" sldId="281"/>
            <ac:spMk id="11" creationId="{00000000-0000-0000-0000-000000000000}"/>
          </ac:spMkLst>
        </pc:spChg>
      </pc:sldChg>
      <pc:sldChg chg="modSp">
        <pc:chgData name="Jiangang Liu" userId="0f1f0531-001f-45a0-a6c2-2f60a9e7edbe" providerId="ADAL" clId="{2D2B3288-9944-40F2-9DC9-8304C1331017}" dt="2020-01-27T18:01:58.422" v="31" actId="207"/>
        <pc:sldMkLst>
          <pc:docMk/>
          <pc:sldMk cId="1357968254" sldId="282"/>
        </pc:sldMkLst>
        <pc:spChg chg="mod">
          <ac:chgData name="Jiangang Liu" userId="0f1f0531-001f-45a0-a6c2-2f60a9e7edbe" providerId="ADAL" clId="{2D2B3288-9944-40F2-9DC9-8304C1331017}" dt="2020-01-27T18:01:58.422" v="31" actId="207"/>
          <ac:spMkLst>
            <pc:docMk/>
            <pc:sldMk cId="1357968254" sldId="282"/>
            <ac:spMk id="14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1BC829-841D-4D7A-94EE-95095887A526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EBAC42-EEBB-46B3-BDC3-D34902C0A4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5169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EBAC42-EEBB-46B3-BDC3-D34902C0A48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80423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2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 Virtual dissect transcriptional networks in CRC with Weighted Gene Co-</a:t>
            </a:r>
            <a:r>
              <a:rPr lang="en-US" sz="1200" b="0" i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Analysis (WGCNA). A. Transcriptome segregated into co-expressed modules based on the similarity of their expression profile in all samples, and each module represented by a distinct color. B. As each module is summarized by a representative eigengene profile, each may then be correlated against a range of clinical variables, allowing visualization of how the transcriptome relates to clinical variables. C and D. Detail for the “GM2-blue” and “GM1-grey60” module. Each horizontal black line represents expression of a single gene within the given module; y axis, gene expression; x axis, patient samples; red line, eigengene profile which effectively summarizes the expression of all genes constituting the module. E. Scatter plot showing correlation between immunosuppression GM2 - blue (x axis) and EMT and angiogenesis GM1-grey60 (y axis) module eigengenes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EBAC42-EEBB-46B3-BDC3-D34902C0A48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3511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S3.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Graphic network depiction of the TME - related modules (GM1 to GM6). For clarity, viewing modules were plotted at different threshold setting to visualize the co-expression network among the top connected genes.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5EBAC42-EEBB-46B3-BDC3-D34902C0A48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0019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6E021E-574A-46B1-AB79-0C2E911FD52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6253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90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927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722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4725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6512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315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682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287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245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0268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94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941586-9560-4DFE-B7A3-B2379BD269BF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1A40A-1BBD-4912-A5CC-8CCC800F2D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225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DEB3F0F-F5BE-40D5-BDDF-E956E06902FA}"/>
              </a:ext>
            </a:extLst>
          </p:cNvPr>
          <p:cNvSpPr/>
          <p:nvPr/>
        </p:nvSpPr>
        <p:spPr>
          <a:xfrm>
            <a:off x="620785" y="105974"/>
            <a:ext cx="7961153" cy="43123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olecular Dissection of CRC Primary Tumors and Their Matched Liver Metastases Reveals Critical Role of Immune Microenvironment, EMT and Angiogenesis in Cancer Metastasis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Jiangang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Liu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*, Yong </a:t>
            </a: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Beom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Cho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3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*, </a:t>
            </a: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Hye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Kyung Hong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*, Song Wu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Philip J. Ebert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Steven M. Bray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Swee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Seong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Wong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Jason C. Ting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John N. Calley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Catherine F. Whittington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Shripad V. Bhagwat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Christoph Reinhard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Robert Wild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Do-Hyun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Nam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3, 5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Amit Aggarwal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6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Woo Yong Lee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2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3,6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, Sheng-Bin Peng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,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1000"/>
              </a:spcAft>
            </a:pP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Eli Lilly and Company, Indianapolis, IN, USA; </a:t>
            </a:r>
            <a:r>
              <a:rPr lang="en-US" sz="1200" baseline="300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Department of Surgery, Samsung Medical Center, Sungkyunkwan University School of Medicine, Seoul, Republic of Korea, 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Department of Health Science and Technology, Samsung Advanced Institute for Health Science &amp; Technology, Sungkyunkwan University, Seoul, Republic of Korea; 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4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Institute for Future Medicine, Samsung Medical Center, Seoul, Republic of Korea,  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5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ea typeface="Malgun Gothic" panose="020B0503020000020004" pitchFamily="34" charset="-127"/>
                <a:cs typeface="Arial" panose="020B0604020202020204" pitchFamily="34" charset="0"/>
              </a:rPr>
              <a:t>epartment of Neurosurgery, Samsung Medical Center, Sungkyunkwan University School of Medicine, Seoul, Republic of Korea; *equal contribution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8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839551" y="1086194"/>
            <a:ext cx="6453543" cy="738664"/>
            <a:chOff x="793145" y="3198154"/>
            <a:chExt cx="6453543" cy="738664"/>
          </a:xfrm>
        </p:grpSpPr>
        <p:sp>
          <p:nvSpPr>
            <p:cNvPr id="1030" name="TextBox 1029"/>
            <p:cNvSpPr txBox="1"/>
            <p:nvPr/>
          </p:nvSpPr>
          <p:spPr>
            <a:xfrm rot="16200000">
              <a:off x="952274" y="3233920"/>
              <a:ext cx="461665" cy="7799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dirty="0"/>
                <a:t>N=3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2705514" y="2971585"/>
              <a:ext cx="738664" cy="1191802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dirty="0"/>
                <a:t>N=13</a:t>
              </a:r>
            </a:p>
            <a:p>
              <a:pPr algn="ctr"/>
              <a:r>
                <a:rPr lang="en-US" dirty="0"/>
                <a:t>(MSI = 3) 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4586449" y="3233594"/>
              <a:ext cx="461665" cy="7799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dirty="0"/>
                <a:t>N=32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6625893" y="3233593"/>
              <a:ext cx="461665" cy="779924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dirty="0"/>
                <a:t>N=32</a:t>
              </a: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9391" y="7422"/>
            <a:ext cx="2569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343958" y="3480967"/>
            <a:ext cx="2720296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1" dirty="0"/>
              <a:t>Clinical inform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1" dirty="0"/>
              <a:t>Somatic mut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1" dirty="0"/>
              <a:t>Copy number variation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b="1" dirty="0"/>
              <a:t>RNA Seq</a:t>
            </a:r>
          </a:p>
        </p:txBody>
      </p:sp>
      <p:sp>
        <p:nvSpPr>
          <p:cNvPr id="17" name="Rectangle 16"/>
          <p:cNvSpPr/>
          <p:nvPr/>
        </p:nvSpPr>
        <p:spPr>
          <a:xfrm>
            <a:off x="728685" y="1732525"/>
            <a:ext cx="1086643" cy="92333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pPr algn="ctr"/>
            <a:r>
              <a:rPr lang="en-US" b="1" dirty="0"/>
              <a:t>Adjacent </a:t>
            </a:r>
          </a:p>
          <a:p>
            <a:pPr algn="ctr"/>
            <a:r>
              <a:rPr lang="en-US" b="1" dirty="0"/>
              <a:t>Normal </a:t>
            </a:r>
          </a:p>
          <a:p>
            <a:pPr algn="ctr"/>
            <a:r>
              <a:rPr lang="en-US" b="1" dirty="0"/>
              <a:t>(AN</a:t>
            </a:r>
            <a:r>
              <a:rPr lang="en-US" sz="1400" b="1" dirty="0"/>
              <a:t>)</a:t>
            </a:r>
          </a:p>
        </p:txBody>
      </p:sp>
      <p:sp>
        <p:nvSpPr>
          <p:cNvPr id="18" name="Rectangle 17"/>
          <p:cNvSpPr/>
          <p:nvPr/>
        </p:nvSpPr>
        <p:spPr>
          <a:xfrm>
            <a:off x="2315804" y="1732524"/>
            <a:ext cx="1578634" cy="122495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rimary Colon </a:t>
            </a:r>
          </a:p>
          <a:p>
            <a:pPr algn="ctr"/>
            <a:r>
              <a:rPr lang="en-US" b="1" dirty="0"/>
              <a:t>without metastasis</a:t>
            </a:r>
          </a:p>
          <a:p>
            <a:pPr algn="ctr"/>
            <a:r>
              <a:rPr lang="en-US" b="1" dirty="0"/>
              <a:t> (CNM)</a:t>
            </a:r>
          </a:p>
        </p:txBody>
      </p:sp>
      <p:sp>
        <p:nvSpPr>
          <p:cNvPr id="19" name="Rectangle 18"/>
          <p:cNvSpPr/>
          <p:nvPr/>
        </p:nvSpPr>
        <p:spPr>
          <a:xfrm>
            <a:off x="4251989" y="1742755"/>
            <a:ext cx="1471249" cy="1206895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Primary Colon with metastasis (CWM)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214945" y="1749647"/>
            <a:ext cx="1578634" cy="120032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Colon Metastasis in Liver </a:t>
            </a:r>
          </a:p>
          <a:p>
            <a:pPr algn="ctr"/>
            <a:r>
              <a:rPr lang="en-US" b="1" dirty="0"/>
              <a:t>(CLM)</a:t>
            </a:r>
          </a:p>
        </p:txBody>
      </p:sp>
      <p:cxnSp>
        <p:nvCxnSpPr>
          <p:cNvPr id="10" name="Straight Connector 9"/>
          <p:cNvCxnSpPr>
            <a:stCxn id="17" idx="2"/>
            <a:endCxn id="20" idx="0"/>
          </p:cNvCxnSpPr>
          <p:nvPr/>
        </p:nvCxnSpPr>
        <p:spPr>
          <a:xfrm>
            <a:off x="1272007" y="2655855"/>
            <a:ext cx="3432099" cy="82511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>
            <a:stCxn id="18" idx="2"/>
            <a:endCxn id="20" idx="0"/>
          </p:cNvCxnSpPr>
          <p:nvPr/>
        </p:nvCxnSpPr>
        <p:spPr>
          <a:xfrm>
            <a:off x="3105121" y="2957475"/>
            <a:ext cx="1598985" cy="523492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>
            <a:stCxn id="19" idx="2"/>
            <a:endCxn id="20" idx="0"/>
          </p:cNvCxnSpPr>
          <p:nvPr/>
        </p:nvCxnSpPr>
        <p:spPr>
          <a:xfrm flipH="1">
            <a:off x="4704106" y="2949650"/>
            <a:ext cx="283508" cy="531317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stCxn id="21" idx="2"/>
            <a:endCxn id="20" idx="0"/>
          </p:cNvCxnSpPr>
          <p:nvPr/>
        </p:nvCxnSpPr>
        <p:spPr>
          <a:xfrm flipH="1">
            <a:off x="4704106" y="2949976"/>
            <a:ext cx="2300156" cy="53099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Rectangle 3"/>
          <p:cNvSpPr/>
          <p:nvPr/>
        </p:nvSpPr>
        <p:spPr>
          <a:xfrm>
            <a:off x="1787517" y="5304620"/>
            <a:ext cx="5625238" cy="369332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r>
              <a:rPr lang="en-US" dirty="0"/>
              <a:t>S1</a:t>
            </a:r>
            <a:r>
              <a:rPr lang="en-US" b="1" dirty="0"/>
              <a:t>:  </a:t>
            </a:r>
            <a:r>
              <a:rPr lang="en-US" dirty="0"/>
              <a:t>Data structure</a:t>
            </a:r>
          </a:p>
        </p:txBody>
      </p:sp>
    </p:spTree>
    <p:extLst>
      <p:ext uri="{BB962C8B-B14F-4D97-AF65-F5344CB8AC3E}">
        <p14:creationId xmlns:p14="http://schemas.microsoft.com/office/powerpoint/2010/main" val="2381304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14" t="3473" r="5099"/>
          <a:stretch/>
        </p:blipFill>
        <p:spPr bwMode="auto">
          <a:xfrm>
            <a:off x="859121" y="1420230"/>
            <a:ext cx="3419534" cy="26504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2366" y="3654349"/>
            <a:ext cx="2760125" cy="1858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5422" y="86285"/>
            <a:ext cx="4406900" cy="1365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784" y="4999734"/>
            <a:ext cx="2760125" cy="18582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6" name="Group 5"/>
          <p:cNvGrpSpPr/>
          <p:nvPr/>
        </p:nvGrpSpPr>
        <p:grpSpPr>
          <a:xfrm>
            <a:off x="609891" y="1775462"/>
            <a:ext cx="493538" cy="3982191"/>
            <a:chOff x="616805" y="1676821"/>
            <a:chExt cx="493538" cy="2318236"/>
          </a:xfrm>
        </p:grpSpPr>
        <p:cxnSp>
          <p:nvCxnSpPr>
            <p:cNvPr id="7" name="Straight Connector 6"/>
            <p:cNvCxnSpPr/>
            <p:nvPr/>
          </p:nvCxnSpPr>
          <p:spPr>
            <a:xfrm flipH="1">
              <a:off x="629099" y="1676821"/>
              <a:ext cx="35389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616805" y="1676821"/>
              <a:ext cx="0" cy="231823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>
              <a:off x="629099" y="3989254"/>
              <a:ext cx="481244" cy="580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Group 9"/>
          <p:cNvGrpSpPr/>
          <p:nvPr/>
        </p:nvGrpSpPr>
        <p:grpSpPr>
          <a:xfrm>
            <a:off x="709595" y="1699709"/>
            <a:ext cx="473483" cy="2387600"/>
            <a:chOff x="636860" y="1607457"/>
            <a:chExt cx="473483" cy="2387600"/>
          </a:xfrm>
        </p:grpSpPr>
        <p:cxnSp>
          <p:nvCxnSpPr>
            <p:cNvPr id="11" name="Straight Connector 10"/>
            <p:cNvCxnSpPr/>
            <p:nvPr/>
          </p:nvCxnSpPr>
          <p:spPr>
            <a:xfrm flipH="1">
              <a:off x="636860" y="1607457"/>
              <a:ext cx="26648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636860" y="1607457"/>
              <a:ext cx="16283" cy="23876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Arrow Connector 12"/>
            <p:cNvCxnSpPr/>
            <p:nvPr/>
          </p:nvCxnSpPr>
          <p:spPr>
            <a:xfrm>
              <a:off x="653143" y="3995057"/>
              <a:ext cx="4572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Box 13"/>
          <p:cNvSpPr txBox="1"/>
          <p:nvPr/>
        </p:nvSpPr>
        <p:spPr>
          <a:xfrm>
            <a:off x="1600468" y="5241128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/>
              <a:t>GM2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1668201" y="3801886"/>
            <a:ext cx="651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/>
              <a:t>GM1</a:t>
            </a:r>
            <a:endParaRPr lang="en-US" dirty="0"/>
          </a:p>
        </p:txBody>
      </p:sp>
      <p:grpSp>
        <p:nvGrpSpPr>
          <p:cNvPr id="18" name="Group 17"/>
          <p:cNvGrpSpPr/>
          <p:nvPr/>
        </p:nvGrpSpPr>
        <p:grpSpPr>
          <a:xfrm>
            <a:off x="3657600" y="4397724"/>
            <a:ext cx="888430" cy="1586123"/>
            <a:chOff x="3657600" y="4138713"/>
            <a:chExt cx="888430" cy="1586123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3657600" y="4138713"/>
              <a:ext cx="53890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4196508" y="4138713"/>
              <a:ext cx="0" cy="4659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/>
            <p:cNvCxnSpPr/>
            <p:nvPr/>
          </p:nvCxnSpPr>
          <p:spPr>
            <a:xfrm>
              <a:off x="4196508" y="4604657"/>
              <a:ext cx="34952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657600" y="5724836"/>
              <a:ext cx="53890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V="1">
              <a:off x="4196508" y="5252512"/>
              <a:ext cx="0" cy="4723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4196508" y="5252512"/>
              <a:ext cx="349522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extBox 25"/>
          <p:cNvSpPr txBox="1"/>
          <p:nvPr/>
        </p:nvSpPr>
        <p:spPr>
          <a:xfrm>
            <a:off x="197113" y="457173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803852" y="4193693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91830" y="532794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591071" y="2612363"/>
            <a:ext cx="3706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256909" y="1515043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100631" y="749016"/>
            <a:ext cx="37181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Weighted Gene Co-</a:t>
            </a:r>
            <a:r>
              <a:rPr lang="en-US" sz="2400" b="1" dirty="0" err="1"/>
              <a:t>expressioN</a:t>
            </a:r>
            <a:r>
              <a:rPr lang="en-US" sz="2400" b="1" dirty="0"/>
              <a:t> Analysis (WGCNA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692748" y="-31805"/>
            <a:ext cx="2433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2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F22C82A-A120-4C68-BBC9-1220489C562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59390" y="3270576"/>
            <a:ext cx="2546964" cy="21396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508664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C:\Users\RX93273\Documents\projects\Samsung\secondEffort\WGCNA\P5\th025blue-03EB2017.png"/>
          <p:cNvPicPr>
            <a:picLocks noGrp="1" noChangeAspect="1" noChangeArrowheads="1"/>
          </p:cNvPicPr>
          <p:nvPr>
            <p:ph sz="half" idx="2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86" r="12242"/>
          <a:stretch/>
        </p:blipFill>
        <p:spPr bwMode="auto">
          <a:xfrm>
            <a:off x="4312382" y="3290893"/>
            <a:ext cx="4721851" cy="32535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7609662" y="2921561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2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477724" y="27468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5" name="Picture 2" descr="C:\Users\RX93273\Documents\projects\Samsung\secondEffort\WGCNA\forManu2\grey60_th022_03FEB2017.png"/>
          <p:cNvPicPr>
            <a:picLocks noGrp="1" noChangeAspect="1" noChangeArrowheads="1"/>
          </p:cNvPicPr>
          <p:nvPr>
            <p:ph sz="half" idx="1"/>
          </p:nvPr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69" r="16269"/>
          <a:stretch/>
        </p:blipFill>
        <p:spPr bwMode="auto">
          <a:xfrm>
            <a:off x="238797" y="579453"/>
            <a:ext cx="5416689" cy="41588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27892" y="39478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77968" y="394787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0" y="0"/>
            <a:ext cx="2433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3</a:t>
            </a:r>
          </a:p>
        </p:txBody>
      </p:sp>
    </p:spTree>
    <p:extLst>
      <p:ext uri="{BB962C8B-B14F-4D97-AF65-F5344CB8AC3E}">
        <p14:creationId xmlns:p14="http://schemas.microsoft.com/office/powerpoint/2010/main" val="34489141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RX93273\Documents\projects\Samsung\secondEffort\WGCNA\forManu2\orangered4_th017_08FEB2017B.png"/>
          <p:cNvPicPr>
            <a:picLocks noGrp="1" noChangeAspect="1" noChangeArrowheads="1"/>
          </p:cNvPicPr>
          <p:nvPr>
            <p:ph sz="half"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0" r="21896"/>
          <a:stretch/>
        </p:blipFill>
        <p:spPr bwMode="auto">
          <a:xfrm>
            <a:off x="0" y="0"/>
            <a:ext cx="6202876" cy="50788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C:\Users\RX93273\Documents\projects\Samsung\secondEffort\WGCNA\forManu2\yellowgreen-th002-03FEB2017.png"/>
          <p:cNvPicPr>
            <a:picLocks noGrp="1" noChangeAspect="1" noChangeArrowheads="1"/>
          </p:cNvPicPr>
          <p:nvPr>
            <p:ph sz="half" idx="2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00" t="193" r="19580" b="1"/>
          <a:stretch/>
        </p:blipFill>
        <p:spPr bwMode="auto">
          <a:xfrm>
            <a:off x="5105400" y="2921230"/>
            <a:ext cx="4038600" cy="34537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6896544" y="273656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4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809272" y="70498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7602" y="848441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466119" y="2459565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2247186" y="3593655"/>
            <a:ext cx="7216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T cell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801133" y="690548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 cell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0" y="0"/>
            <a:ext cx="2433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3</a:t>
            </a:r>
          </a:p>
        </p:txBody>
      </p:sp>
    </p:spTree>
    <p:extLst>
      <p:ext uri="{BB962C8B-B14F-4D97-AF65-F5344CB8AC3E}">
        <p14:creationId xmlns:p14="http://schemas.microsoft.com/office/powerpoint/2010/main" val="249516133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 descr="C:\Users\RX93273\Documents\projects\Samsung\secondEffort\WGCNA\forManu2\lightsteelblue1-th005-03FEB2017.png"/>
          <p:cNvPicPr>
            <a:picLocks noGrp="1" noChangeAspect="1" noChangeArrowheads="1"/>
          </p:cNvPicPr>
          <p:nvPr>
            <p:ph sz="half"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97" r="20345"/>
          <a:stretch/>
        </p:blipFill>
        <p:spPr bwMode="auto">
          <a:xfrm>
            <a:off x="368418" y="878514"/>
            <a:ext cx="4038600" cy="34938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122628" y="509182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5</a:t>
            </a:r>
          </a:p>
        </p:txBody>
      </p:sp>
      <p:pic>
        <p:nvPicPr>
          <p:cNvPr id="9" name="Picture 2" descr="C:\Users\RX93273\Documents\projects\Samsung\secondEffort\WGCNA\forManu2\darkolivergreen-th010-23JAN2017.png"/>
          <p:cNvPicPr>
            <a:picLocks noGrp="1" noChangeAspect="1" noChangeArrowheads="1"/>
          </p:cNvPicPr>
          <p:nvPr>
            <p:ph sz="half" idx="2"/>
          </p:nvPr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42" r="16724"/>
          <a:stretch/>
        </p:blipFill>
        <p:spPr bwMode="auto">
          <a:xfrm>
            <a:off x="4407018" y="2788466"/>
            <a:ext cx="4281471" cy="33583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5190451" y="2297164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M6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68418" y="509182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98833" y="2802348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0" y="0"/>
            <a:ext cx="2433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S3</a:t>
            </a:r>
          </a:p>
        </p:txBody>
      </p:sp>
    </p:spTree>
    <p:extLst>
      <p:ext uri="{BB962C8B-B14F-4D97-AF65-F5344CB8AC3E}">
        <p14:creationId xmlns:p14="http://schemas.microsoft.com/office/powerpoint/2010/main" val="1357968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521C125E49DD749B31C63E4D2141EEB" ma:contentTypeVersion="4" ma:contentTypeDescription="Create a new document." ma:contentTypeScope="" ma:versionID="52826b08387ccf785b343747098e0d7c">
  <xsd:schema xmlns:xsd="http://www.w3.org/2001/XMLSchema" xmlns:xs="http://www.w3.org/2001/XMLSchema" xmlns:p="http://schemas.microsoft.com/office/2006/metadata/properties" xmlns:ns2="eda0ff45-9e4e-4f0d-8345-05354f6b322d" targetNamespace="http://schemas.microsoft.com/office/2006/metadata/properties" ma:root="true" ma:fieldsID="7fae558ffc7aea2ab8764318786b2f83" ns2:_="">
    <xsd:import namespace="eda0ff45-9e4e-4f0d-8345-05354f6b322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da0ff45-9e4e-4f0d-8345-05354f6b322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1AD7412-DBBA-4D37-987C-2333FFA869F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da0ff45-9e4e-4f0d-8345-05354f6b322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20EACC6D-B1ED-4BAC-BABC-6DDF864F0BBB}">
  <ds:schemaRefs>
    <ds:schemaRef ds:uri="http://purl.org/dc/dcmitype/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infopath/2007/PartnerControls"/>
    <ds:schemaRef ds:uri="eda0ff45-9e4e-4f0d-8345-05354f6b322d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6131F1AB-124C-4D59-AA28-783BB8B5E34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570</TotalTime>
  <Words>141</Words>
  <Application>Microsoft Office PowerPoint</Application>
  <PresentationFormat>On-screen Show (4:3)</PresentationFormat>
  <Paragraphs>56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li Lilly an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. Liu</dc:creator>
  <cp:lastModifiedBy>Sheng-Bin Peng</cp:lastModifiedBy>
  <cp:revision>65</cp:revision>
  <dcterms:created xsi:type="dcterms:W3CDTF">2017-08-21T13:52:24Z</dcterms:created>
  <dcterms:modified xsi:type="dcterms:W3CDTF">2020-03-11T18:34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521C125E49DD749B31C63E4D2141EEB</vt:lpwstr>
  </property>
</Properties>
</file>